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54" d="100"/>
          <a:sy n="154" d="100"/>
        </p:scale>
        <p:origin x="-226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Объект 2">
            <a:extLst>
              <a:ext uri="{FF2B5EF4-FFF2-40B4-BE49-F238E27FC236}">
                <a16:creationId xmlns:a16="http://schemas.microsoft.com/office/drawing/2014/main" xmlns="" id="{B5A1926C-F1CF-5BDA-0061-F4962B0CECDA}"/>
              </a:ext>
            </a:extLst>
          </p:cNvPr>
          <p:cNvSpPr txBox="1">
            <a:spLocks/>
          </p:cNvSpPr>
          <p:nvPr/>
        </p:nvSpPr>
        <p:spPr>
          <a:xfrm>
            <a:off x="155448" y="5943600"/>
            <a:ext cx="8862822" cy="576073"/>
          </a:xfrm>
          <a:prstGeom prst="rect">
            <a:avLst/>
          </a:prstGeom>
        </p:spPr>
        <p:txBody>
          <a:bodyPr vert="horz" lIns="91440" tIns="45720" rIns="91440" bIns="45720" rtlCol="0">
            <a:normAutofit fontScale="92500" lnSpcReduction="20000"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uster analysis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as based on the difference between upregulated and downregulated DEGs in each comparison groups.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ach row represents a pathway; n = 3 per group. Only those pathways and genes with cut-off &gt;1.5 and </a:t>
            </a:r>
            <a:r>
              <a:rPr lang="en-US" sz="1400" i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lt; 0.05 were selected as significant results.</a:t>
            </a:r>
            <a:endParaRPr lang="ru-RU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Прямоугольник 8"/>
          <p:cNvSpPr/>
          <p:nvPr/>
        </p:nvSpPr>
        <p:spPr>
          <a:xfrm>
            <a:off x="169865" y="76200"/>
            <a:ext cx="874553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ierarchical cluster analysis of pathways according to the differential gene expression profiles in IR-s vs. SO-s and IR-f vs. SO-f pairwis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mparisons.</a:t>
            </a:r>
            <a:endParaRPr lang="en-US" sz="1400" b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sp>
        <p:nvSpPr>
          <p:cNvPr id="3" name="Прямоугольник 2"/>
          <p:cNvSpPr/>
          <p:nvPr/>
        </p:nvSpPr>
        <p:spPr>
          <a:xfrm>
            <a:off x="3433119" y="5334000"/>
            <a:ext cx="2116135" cy="3048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ru-RU"/>
          </a:p>
        </p:txBody>
      </p:sp>
      <p:pic>
        <p:nvPicPr>
          <p:cNvPr id="1030" name="Picture 6" descr="K:\Редактируемые\Для публикаций\0_текущие публикации\ишемия_2\стриатум 24h\статья по 24 часам striat\1_IR Str-FC\fs2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61327" y="1035171"/>
            <a:ext cx="4659718" cy="44512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22790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0</TotalTime>
  <Words>76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Office Them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Ivan</cp:lastModifiedBy>
  <cp:revision>15</cp:revision>
  <dcterms:created xsi:type="dcterms:W3CDTF">2006-08-16T00:00:00Z</dcterms:created>
  <dcterms:modified xsi:type="dcterms:W3CDTF">2025-01-14T14:19:51Z</dcterms:modified>
</cp:coreProperties>
</file>